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3FAB1-BDC0-4398-A9FD-7BCBE4B101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672CE-7A07-41AE-BDD2-1E097A75DC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DADCA-C55D-4AF2-BBDA-558F0E1441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48D335-929D-4BDB-873F-CD6A00B9A9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DA399-603F-4730-AD85-7AA453D1B3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0EF76-3C0D-43CE-8EF8-32420EFD55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2989C-33C8-4A52-BD5C-508511E184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C16AB-9DDB-439A-9346-2CBEEADE38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5EFD2-7FAB-4085-9F7F-037C4DF67F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A6841-ECC2-4580-B064-4911D0EDE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9E8F0-1DB0-463B-AB30-2BF5FCC809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F8843-AE5B-4064-9AB5-DD50882277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265496-76CD-412F-AAA1-1033B73859D7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53AF44-8D47-4AE7-AC62-59BB4B8D227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Significance Curve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57200" y="1600200"/>
          <a:ext cx="8229600" cy="4079880"/>
        </p:xfrm>
        <a:graphic>
          <a:graphicData uri="http://schemas.openxmlformats.org/drawingml/2006/table">
            <a:tbl>
              <a:tblPr/>
              <a:tblGrid>
                <a:gridCol w="2743200"/>
                <a:gridCol w="2743200"/>
                <a:gridCol w="2743200"/>
              </a:tblGrid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eta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Regression Curv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ignificance Curv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369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0219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089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0219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23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0297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063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0297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1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36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072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36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09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2408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213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2408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29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71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i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0545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074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0545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1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b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1777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157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1777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21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1986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022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1986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03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69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5.6762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209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5.6762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28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2332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157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2332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2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0808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103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=0.0808</a:t>
                      </a:r>
                      <a:r>
                        <a:rPr b="0" i="1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</a:t>
                      </a:r>
                      <a:r>
                        <a:rPr b="0" lang="en-US" sz="1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^(-0.14x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uster Generation Call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90000"/>
              </a:lnSpc>
              <a:spcBef>
                <a:spcPts val="3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Ward Clustering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where X.csv contains peptide hit counts across ORFs/fractions for GMPA score significant ORFs for a given metal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lvl="1" marL="971640" indent="-514440">
              <a:lnSpc>
                <a:spcPct val="90000"/>
              </a:lnSpc>
              <a:spcBef>
                <a:spcPts val="649"/>
              </a:spcBef>
              <a:buClr>
                <a:srgbClr val="000000"/>
              </a:buClr>
              <a:buFont typeface="Calibri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X &lt;- read.csv(“X.csv", head=TRUE, row.names=1)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1" marL="971640" indent="-514440">
              <a:lnSpc>
                <a:spcPct val="90000"/>
              </a:lnSpc>
              <a:spcBef>
                <a:spcPts val="649"/>
              </a:spcBef>
              <a:buClr>
                <a:srgbClr val="000000"/>
              </a:buClr>
              <a:buFont typeface="Calibri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X[X&gt;1]&lt;-1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1" marL="971640" indent="-514440">
              <a:lnSpc>
                <a:spcPct val="90000"/>
              </a:lnSpc>
              <a:spcBef>
                <a:spcPts val="649"/>
              </a:spcBef>
              <a:buClr>
                <a:srgbClr val="000000"/>
              </a:buClr>
              <a:buFont typeface="Calibri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d &lt;- dist(X)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1" marL="971640" indent="-514440">
              <a:lnSpc>
                <a:spcPct val="90000"/>
              </a:lnSpc>
              <a:spcBef>
                <a:spcPts val="649"/>
              </a:spcBef>
              <a:buClr>
                <a:srgbClr val="000000"/>
              </a:buClr>
              <a:buFont typeface="Calibri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hc &lt;- hclust(d, "ward")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"/>
              </a:rPr>
              <a:t>cutreeHybrid (through cutreeDynamic wrapper)</a:t>
            </a:r>
            <a:endParaRPr b="0" lang="en-US" sz="3000" spc="-1" strike="noStrike">
              <a:solidFill>
                <a:srgbClr val="000000"/>
              </a:solidFill>
              <a:latin typeface="Calibri"/>
            </a:endParaRPr>
          </a:p>
          <a:p>
            <a:pPr lvl="1" marL="971640" indent="-514440">
              <a:lnSpc>
                <a:spcPct val="90000"/>
              </a:lnSpc>
              <a:spcBef>
                <a:spcPts val="649"/>
              </a:spcBef>
              <a:buClr>
                <a:srgbClr val="000000"/>
              </a:buClr>
              <a:buFont typeface="Calibri"/>
              <a:buAutoNum type="arabicParenR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alibri"/>
              </a:rPr>
              <a:t>cutreeDynamic(hc, cutHeight = NULL, minClusterSize = 6, method = "hybrid", deepSplit = 3, pamStage = TRUE,  distM = as.matrix(d), maxDistToLabel = 0, verbose = 0);</a:t>
            </a: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  <a:p>
            <a:pPr lvl="1" marL="971640" indent="-514440">
              <a:lnSpc>
                <a:spcPct val="90000"/>
              </a:lnSpc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3"/>
          <p:cNvSpPr/>
          <p:nvPr/>
        </p:nvSpPr>
        <p:spPr>
          <a:xfrm>
            <a:off x="243000" y="6273720"/>
            <a:ext cx="8658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Note: cutreeHybrid as called will in some cases return clusters or unlabeled groupings smaller than “minClusterSize” (e.g. see Co clustering) as explained in supplementary material to Langfelder et al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0T13:39:54Z</dcterms:created>
  <dc:creator>jpraissman</dc:creator>
  <dc:description/>
  <dc:language>en-US</dc:language>
  <cp:lastModifiedBy>Michael W. W. Adams</cp:lastModifiedBy>
  <dcterms:modified xsi:type="dcterms:W3CDTF">2010-10-10T13:58:21Z</dcterms:modified>
  <cp:revision>32</cp:revision>
  <dc:subject/>
  <dc:title>Significance Curves</dc:title>
</cp:coreProperties>
</file>